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77" y="21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CA6F2E-0624-4E14-B857-A464B69AF05C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6025DF-A13F-42C2-AF96-7B3E6B004A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292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025DF-A13F-42C2-AF96-7B3E6B004A5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2146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025DF-A13F-42C2-AF96-7B3E6B004A5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32335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025DF-A13F-42C2-AF96-7B3E6B004A52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816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C8D3FE-C198-42E0-846E-1587951460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97E9886-89A3-4406-9F09-5076D62CDD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EAB3E0-E60B-45D9-A900-9A846B9D4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14E122-0AA9-4B04-A282-FD80E4BA4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29F6DE-321B-4FCF-8F90-DE35C63E6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815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AD6639-12F5-46D9-BC37-96AB3B127B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629F148-CA1A-4ABE-BFF9-D820B3B48F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A116EA-9EBE-498F-9813-C06B4049D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5BC0E6-0DE5-402E-930B-BE52A654B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79AB3C-B23F-48FE-8B61-3E7FA044FF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7978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824EF5E-AA4C-4C93-9114-0B59AF6E26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FA050CE-DB6F-4BD6-BB5E-958EFFC638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720ABC-2290-45DE-96A4-BCC29159A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76D810-8671-402C-9ABB-BFDD4F9A4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342DFA6-6CAC-4476-83DC-2B0CDFAD0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974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3BC79D-C681-48A7-A748-DA302866D9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89EB852-87B8-4C32-9EDD-B5D41EF82A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486C38-7E86-4A56-9229-42510FE90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4D5D8C-A14E-44D8-B832-2748BDBD8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E8D641-2D75-4515-9DD3-33C03B91E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429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4B6017-47AB-49D0-B63E-E6B9BB3C8C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C50C68E-546B-486B-9F7D-6356563C4E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9E7ABB-F54E-4FA4-BC9C-D6EED617C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95B1DC-35C2-409C-895D-AB14E966D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C4D31D-6D38-4641-9C9C-0B968F044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742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98AAB7-5B85-4092-AEF8-97226B7608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4E533F4-308B-45AF-83F9-494D991525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4F4EAD1-2797-4954-8E4C-F361103E1F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EF2D9FF-0716-4D0C-A7EA-F7DF92E8D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CC8A12-1A09-4CEE-9C18-040086AFF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4FC805E-6314-4D91-AE67-F7A483083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9977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01AE42-7C1F-4641-83FD-1F31EBDE76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8D216FD-86CA-40C9-8F89-5C54F6C714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EFCADA1-F948-4EA7-BFAD-6C3F751303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AE61777-FFAC-4ADE-9E05-D92ACDE7E1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A214C6B-0E9D-439C-B216-426517F669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3F2F462-989F-4700-82E9-FF7A99164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1086712-2CDB-4A71-88F2-31504D13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903D8F1-F56B-4762-A1C5-E169358DE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68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BA58A3-F22C-43C7-805B-9931A76689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0915AC5-979E-49F5-89F2-D1F396F97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6E49C22-C5F9-4CB9-A016-F5F35A5772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9D025FE-6667-413F-B489-BBCC227F8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684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4D5BB1B-F102-4865-8DD4-64030ECDB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C2691A9-4307-4707-B21E-4A44D6D4D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A145C28-01C8-4F07-A573-B66E28122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1903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D909BB-E6CB-4019-B664-21EB5CC5D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FD5B796-FA8C-41BE-A2B2-D00BBBAF66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599979C-1E11-4F4A-9E4B-DA623BF237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FD127D3-27D2-44F2-B2F4-7BBE68A14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F900D02-00AF-4AB5-BB16-EC3559190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3BD7CBC-E536-4552-B84A-AFDE45711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1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9E3B73-4122-4CE2-9334-2FE2918E24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5844AA5-90E7-4F4A-859E-0764A836C1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49523CF-D4D0-4079-812D-DA15FC210B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0EC46BA-7670-4219-8BAE-F6F7CED64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2EB39B3-5005-4703-8A68-477B2F1CA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8381279-7C5C-4F6A-A114-703A8D51A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888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69640C8-A919-496D-B207-EA335459D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FE4A0EE-CA82-4C64-9954-12EE14453C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55E995-F7DF-41C2-A52F-EF32D80614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FFDD9-D346-4D00-AE3C-B1D53D31C235}" type="datetimeFigureOut">
              <a:rPr kumimoji="1" lang="ja-JP" altLang="en-US" smtClean="0"/>
              <a:t>2021/11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83FC51-A046-4C48-A533-DAC2B8FBD3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1D13D2-52ED-48BA-A330-32EE03195B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25B62-2E3A-464C-A26B-4415E8223C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4685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56524232-A118-4E62-BED3-096471E26D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60" y="119335"/>
            <a:ext cx="5071541" cy="5065511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4CF86FB7-D72E-42E5-8BCD-83B28E0A25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84207" y="121896"/>
            <a:ext cx="5071541" cy="5065512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A6830314-E8EB-4B2E-AE29-6D47B237A06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23" r="20156"/>
          <a:stretch/>
        </p:blipFill>
        <p:spPr>
          <a:xfrm>
            <a:off x="8134517" y="128097"/>
            <a:ext cx="4057484" cy="5059311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879E2FF-48F6-476A-B3F2-0E004FD57A01}"/>
              </a:ext>
            </a:extLst>
          </p:cNvPr>
          <p:cNvSpPr txBox="1"/>
          <p:nvPr/>
        </p:nvSpPr>
        <p:spPr>
          <a:xfrm>
            <a:off x="4089934" y="50795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1BF978C-5944-4EC0-84A9-F6B4027C76F2}"/>
              </a:ext>
            </a:extLst>
          </p:cNvPr>
          <p:cNvSpPr txBox="1"/>
          <p:nvPr/>
        </p:nvSpPr>
        <p:spPr>
          <a:xfrm>
            <a:off x="9947" y="5515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C4B14E1-8F45-4E32-AE89-609D027B4780}"/>
              </a:ext>
            </a:extLst>
          </p:cNvPr>
          <p:cNvSpPr txBox="1"/>
          <p:nvPr/>
        </p:nvSpPr>
        <p:spPr>
          <a:xfrm>
            <a:off x="8135067" y="5514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83E525D-AF32-4DD3-9386-D6425B981E24}"/>
              </a:ext>
            </a:extLst>
          </p:cNvPr>
          <p:cNvSpPr txBox="1"/>
          <p:nvPr/>
        </p:nvSpPr>
        <p:spPr>
          <a:xfrm>
            <a:off x="9948" y="5501876"/>
            <a:ext cx="12182052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 plots for estimating causal effects of genetically predicted serum Apo-B levels on risk of (a) susceptibility, (b) hospitalization, and (c) severity. Each black point representing the effect size of each SNP on the exposure (horizontal-axis) and on the outcome (vertical-axi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ted with error bars corresponding to each SE. The slope of each line corresponds to the combined estimate using each method of the IVW (light blue line), the MR-Egger regression (blue line), the weighted median (light green line), and the weighted mode (green line)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6480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F99D29A8-700E-4319-999D-BF1E3C25D7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9" y="123103"/>
            <a:ext cx="5069611" cy="5063584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2A9B2771-6EEF-4078-A3A5-4A547C61C5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84638" y="126891"/>
            <a:ext cx="5071542" cy="5065512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B24AC0AF-BDDB-469C-8415-66DB675F944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2" r="19942" b="1"/>
          <a:stretch/>
        </p:blipFill>
        <p:spPr>
          <a:xfrm>
            <a:off x="8130904" y="120500"/>
            <a:ext cx="4061096" cy="5065512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023CAF5-8E18-459C-A828-379F0B43B116}"/>
              </a:ext>
            </a:extLst>
          </p:cNvPr>
          <p:cNvSpPr txBox="1"/>
          <p:nvPr/>
        </p:nvSpPr>
        <p:spPr>
          <a:xfrm>
            <a:off x="4089934" y="50795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2B446FB-E072-443E-A4EF-091F0C511CF2}"/>
              </a:ext>
            </a:extLst>
          </p:cNvPr>
          <p:cNvSpPr txBox="1"/>
          <p:nvPr/>
        </p:nvSpPr>
        <p:spPr>
          <a:xfrm>
            <a:off x="9947" y="5515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CF95839-023F-4658-B532-20E1B36E4658}"/>
              </a:ext>
            </a:extLst>
          </p:cNvPr>
          <p:cNvSpPr txBox="1"/>
          <p:nvPr/>
        </p:nvSpPr>
        <p:spPr>
          <a:xfrm>
            <a:off x="8135067" y="55142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4F85238-61BE-4561-958C-254DA9446024}"/>
              </a:ext>
            </a:extLst>
          </p:cNvPr>
          <p:cNvSpPr txBox="1"/>
          <p:nvPr/>
        </p:nvSpPr>
        <p:spPr>
          <a:xfrm>
            <a:off x="9948" y="5502297"/>
            <a:ext cx="1218205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 plots for estimating causal effects of genetically predicted serum LDL-C levels on risk of (a) susceptibility, (b) hospitalization, and (c) severity. Each black point representing the effect size of each SNP on the exposure (horizontal-axis) and on the outcome (vertical-axis)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ted with error bars corresponding to each SE. The slope of each line corresponds to the combined estimate using each method of the IVW (light blue line), the MR-Egger regression (blue line), the weighted median (light green line), and the weighted mode (green line)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19834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ECC36BF-D0C8-4846-9D2D-98F31DC9BC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749" y="140446"/>
            <a:ext cx="6408975" cy="6401355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E79FADEA-5492-4DFF-80A8-B57E527031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81691" y="138888"/>
            <a:ext cx="6408975" cy="640135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B16CFA1-07B0-4BBE-9734-ABD6ECFDB740}"/>
              </a:ext>
            </a:extLst>
          </p:cNvPr>
          <p:cNvSpPr txBox="1"/>
          <p:nvPr/>
        </p:nvSpPr>
        <p:spPr>
          <a:xfrm>
            <a:off x="5782534" y="57504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AB94538-76B2-4D47-93C5-1341CF28A54C}"/>
              </a:ext>
            </a:extLst>
          </p:cNvPr>
          <p:cNvSpPr txBox="1"/>
          <p:nvPr/>
        </p:nvSpPr>
        <p:spPr>
          <a:xfrm>
            <a:off x="-1504" y="56004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81C6A6A-0766-426D-B5C4-3ABE938FE7AA}"/>
              </a:ext>
            </a:extLst>
          </p:cNvPr>
          <p:cNvSpPr txBox="1"/>
          <p:nvPr/>
        </p:nvSpPr>
        <p:spPr>
          <a:xfrm>
            <a:off x="9948" y="5255826"/>
            <a:ext cx="1218205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Leave-one-out sensitivity analysis for estimating causal effect of genetically predicted serum TG levels on risk of COVID-19 severity. Each black point represents the combined causal estimate using the IVW method and horizontal line represents 95% CI after removing each corresponding SNP from the analysis. (b) Funnel plot for estimating causal effect of serum TG levels on risk of COVID-19 severity. Each black point representing the Beta and the inverse of corresponding SE of each SNP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ted on horizontal-axis and on vertical-axis, respectively. Vertical lines show the combined estimates using the IVW (light blue) and the MR-Egger regression (blue line) methods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5219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</TotalTime>
  <Words>369</Words>
  <Application>Microsoft Office PowerPoint</Application>
  <PresentationFormat>ワイド画面</PresentationFormat>
  <Paragraphs>17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yosh</dc:creator>
  <cp:lastModifiedBy>myosh</cp:lastModifiedBy>
  <cp:revision>19</cp:revision>
  <dcterms:created xsi:type="dcterms:W3CDTF">2021-09-14T23:13:03Z</dcterms:created>
  <dcterms:modified xsi:type="dcterms:W3CDTF">2021-11-05T03:31:57Z</dcterms:modified>
</cp:coreProperties>
</file>